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62" r:id="rId2"/>
    <p:sldId id="263" r:id="rId3"/>
    <p:sldId id="258" r:id="rId4"/>
    <p:sldId id="259" r:id="rId5"/>
    <p:sldId id="260" r:id="rId6"/>
    <p:sldId id="261" r:id="rId7"/>
    <p:sldId id="266" r:id="rId8"/>
    <p:sldId id="267" r:id="rId9"/>
    <p:sldId id="268" r:id="rId10"/>
    <p:sldId id="269" r:id="rId11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3542" autoAdjust="0"/>
  </p:normalViewPr>
  <p:slideViewPr>
    <p:cSldViewPr>
      <p:cViewPr>
        <p:scale>
          <a:sx n="75" d="100"/>
          <a:sy n="75" d="100"/>
        </p:scale>
        <p:origin x="-1776" y="135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0B0C4E3-08AD-491C-81D5-4AAC3A1EF689}" type="datetimeFigureOut">
              <a:rPr lang="zh-CN" altLang="en-US" smtClean="0"/>
              <a:t>2021/10/1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5002DE8-8C7D-4413-A8CD-5746FCD47E5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96148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104F781-9BB8-4D24-A1B1-98498DD1C8D0}" type="slidenum">
              <a:rPr lang="zh-CN" altLang="en-US" smtClean="0"/>
              <a:t>7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155347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104F781-9BB8-4D24-A1B1-98498DD1C8D0}" type="slidenum">
              <a:rPr lang="zh-CN" altLang="en-US" smtClean="0"/>
              <a:t>8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634058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0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0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0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0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0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0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0/1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0/1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0/1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0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10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1/10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10" Type="http://schemas.openxmlformats.org/officeDocument/2006/relationships/image" Target="../media/image17.png"/><Relationship Id="rId4" Type="http://schemas.openxmlformats.org/officeDocument/2006/relationships/image" Target="../media/image11.png"/><Relationship Id="rId9" Type="http://schemas.openxmlformats.org/officeDocument/2006/relationships/image" Target="../media/image1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jpe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0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jpeg"/><Relationship Id="rId2" Type="http://schemas.openxmlformats.org/officeDocument/2006/relationships/image" Target="../media/image2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3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jpeg"/><Relationship Id="rId2" Type="http://schemas.openxmlformats.org/officeDocument/2006/relationships/image" Target="../media/image24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6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jpeg"/><Relationship Id="rId2" Type="http://schemas.openxmlformats.org/officeDocument/2006/relationships/image" Target="../media/image27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9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jpeg"/><Relationship Id="rId2" Type="http://schemas.openxmlformats.org/officeDocument/2006/relationships/image" Target="../media/image32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5" name="组合 44"/>
          <p:cNvGrpSpPr/>
          <p:nvPr/>
        </p:nvGrpSpPr>
        <p:grpSpPr>
          <a:xfrm>
            <a:off x="476672" y="585457"/>
            <a:ext cx="5904656" cy="5342390"/>
            <a:chOff x="492109" y="735487"/>
            <a:chExt cx="5904656" cy="5342390"/>
          </a:xfrm>
        </p:grpSpPr>
        <p:sp>
          <p:nvSpPr>
            <p:cNvPr id="22" name="矩形 21"/>
            <p:cNvSpPr/>
            <p:nvPr/>
          </p:nvSpPr>
          <p:spPr>
            <a:xfrm>
              <a:off x="492109" y="735489"/>
              <a:ext cx="2897653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WAS</a:t>
              </a:r>
              <a:r>
                <a:rPr lang="zh-CN" alt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on</a:t>
              </a:r>
              <a:r>
                <a: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almitic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 acid 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zh-CN" sz="12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mponent 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)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矩形 24"/>
            <p:cNvSpPr/>
            <p:nvPr/>
          </p:nvSpPr>
          <p:spPr>
            <a:xfrm>
              <a:off x="3444437" y="735487"/>
              <a:ext cx="2878417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WAS</a:t>
              </a:r>
              <a:r>
                <a:rPr lang="zh-CN" alt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on</a:t>
              </a:r>
              <a:r>
                <a: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Linoleic acid 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zh-CN" sz="12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mponent 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)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矩形 27"/>
            <p:cNvSpPr/>
            <p:nvPr/>
          </p:nvSpPr>
          <p:spPr>
            <a:xfrm>
              <a:off x="503062" y="2227460"/>
              <a:ext cx="2710101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WAS</a:t>
              </a:r>
              <a:r>
                <a:rPr lang="zh-CN" alt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on</a:t>
              </a:r>
              <a:r>
                <a: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Oleic acid 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zh-CN" sz="12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mponent 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)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矩形 30"/>
            <p:cNvSpPr/>
            <p:nvPr/>
          </p:nvSpPr>
          <p:spPr>
            <a:xfrm>
              <a:off x="3444437" y="2227459"/>
              <a:ext cx="2838341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WAS</a:t>
              </a:r>
              <a:r>
                <a:rPr lang="zh-CN" alt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on</a:t>
              </a:r>
              <a:r>
                <a: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Stearic acid 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zh-CN" sz="12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mponent 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)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矩形 33"/>
            <p:cNvSpPr/>
            <p:nvPr/>
          </p:nvSpPr>
          <p:spPr>
            <a:xfrm>
              <a:off x="492109" y="3828317"/>
              <a:ext cx="2701637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WAS</a:t>
              </a:r>
              <a:r>
                <a:rPr lang="zh-CN" alt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on</a:t>
              </a:r>
              <a:r>
                <a: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Tricosane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zh-CN" sz="12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mponent 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)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矩形 36"/>
            <p:cNvSpPr/>
            <p:nvPr/>
          </p:nvSpPr>
          <p:spPr>
            <a:xfrm>
              <a:off x="3465450" y="3829053"/>
              <a:ext cx="2931315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WAS</a:t>
              </a:r>
              <a:r>
                <a:rPr lang="zh-CN" alt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on</a:t>
              </a:r>
              <a:r>
                <a: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entacosane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zh-CN" sz="12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mponent 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)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矩形 39"/>
            <p:cNvSpPr/>
            <p:nvPr/>
          </p:nvSpPr>
          <p:spPr>
            <a:xfrm>
              <a:off x="492109" y="5616212"/>
              <a:ext cx="2939331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WAS</a:t>
              </a:r>
              <a:r>
                <a:rPr lang="zh-CN" alt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on</a:t>
              </a:r>
              <a:r>
                <a: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eptacosane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zh-CN" sz="12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mponent 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)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矩形 42"/>
            <p:cNvSpPr/>
            <p:nvPr/>
          </p:nvSpPr>
          <p:spPr>
            <a:xfrm>
              <a:off x="3493278" y="5616210"/>
              <a:ext cx="2903487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WAS</a:t>
              </a:r>
              <a:r>
                <a:rPr lang="zh-CN" alt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on</a:t>
              </a:r>
              <a:r>
                <a: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Tetracosanol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zh-CN" sz="12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mponent 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)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6" name="TextBox 45"/>
          <p:cNvSpPr txBox="1"/>
          <p:nvPr/>
        </p:nvSpPr>
        <p:spPr>
          <a:xfrm>
            <a:off x="138798" y="6876256"/>
            <a:ext cx="6484522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1 The GWAS 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sults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of different wax components of apple leaves (</a:t>
            </a:r>
            <a:r>
              <a:rPr lang="en-US" altLang="zh-CN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mponents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1 to 8).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he GWAS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sults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of different wax components of apple leaves.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anhattan plots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of GWAS is on the left. The chromosome number is plotted on the X-axis and the -log</a:t>
            </a:r>
            <a:r>
              <a:rPr lang="en-US" altLang="zh-CN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value of the 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p-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value is plotted on Y-axis. The dotted lines indicate -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altLang="zh-CN" sz="12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=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. </a:t>
            </a:r>
            <a:r>
              <a:rPr lang="en-US" altLang="zh-CN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Quantile-quantile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Q-Q)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lots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WAS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s on the right. The expected -log</a:t>
            </a:r>
            <a:r>
              <a:rPr lang="en-US" altLang="zh-CN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value of the 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p-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value is on the X-axis and the observed -log</a:t>
            </a:r>
            <a:r>
              <a:rPr lang="en-US" altLang="zh-CN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value of the 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p-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value is on Y-axis.</a:t>
            </a:r>
            <a:endParaRPr lang="zh-CN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960" y="885965"/>
            <a:ext cx="2880000" cy="7200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81687" y="891366"/>
            <a:ext cx="2880000" cy="720000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960" y="2327847"/>
            <a:ext cx="2880000" cy="72000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81687" y="2308262"/>
            <a:ext cx="2880000" cy="72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640" y="4067944"/>
            <a:ext cx="2880000" cy="72000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84617" y="4067944"/>
            <a:ext cx="2880000" cy="720000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640" y="5961015"/>
            <a:ext cx="2880000" cy="720000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3016" y="5961529"/>
            <a:ext cx="2880000" cy="72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5779730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188639" y="827584"/>
            <a:ext cx="6669361" cy="22621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defRPr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omparative analyses 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altLang="zh-CN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MdLTP4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MdWSD1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, and </a:t>
            </a:r>
            <a:r>
              <a:rPr lang="en-US" altLang="zh-CN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MdRDR1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between the low and high 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ax haplotypes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ccording to the most significant SNP of their 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romoters.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oxplot shows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he content</a:t>
            </a:r>
            <a:r>
              <a:rPr lang="zh-CN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zh-CN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wax of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each haplotype. The box expresses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he upper,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e median, and lower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quartiles, and the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ots represent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extremes. Different letters indicate significant differences at </a:t>
            </a:r>
            <a:r>
              <a:rPr lang="en-US" altLang="zh-CN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&lt;0.05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ccording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o one-way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nalysis of variance (ANOVA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. The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able represents the location of the most significant SNP of their promoters and the accessions number corresponding to each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aplotype.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101965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5" name="组合 54"/>
          <p:cNvGrpSpPr/>
          <p:nvPr/>
        </p:nvGrpSpPr>
        <p:grpSpPr>
          <a:xfrm>
            <a:off x="332656" y="316666"/>
            <a:ext cx="6575760" cy="6661215"/>
            <a:chOff x="354087" y="643529"/>
            <a:chExt cx="6575760" cy="6661215"/>
          </a:xfrm>
        </p:grpSpPr>
        <p:sp>
          <p:nvSpPr>
            <p:cNvPr id="7" name="矩形 6"/>
            <p:cNvSpPr/>
            <p:nvPr/>
          </p:nvSpPr>
          <p:spPr>
            <a:xfrm>
              <a:off x="354087" y="650391"/>
              <a:ext cx="300665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GWAS</a:t>
              </a:r>
              <a:r>
                <a: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on</a:t>
              </a:r>
              <a:r>
                <a: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lignoceric acid</a:t>
              </a:r>
              <a:r>
                <a: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zh-CN" sz="12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mponent 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矩形 8"/>
            <p:cNvSpPr/>
            <p:nvPr/>
          </p:nvSpPr>
          <p:spPr>
            <a:xfrm>
              <a:off x="3522439" y="643529"/>
              <a:ext cx="2981009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GWAS</a:t>
              </a:r>
              <a:r>
                <a: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on</a:t>
              </a:r>
              <a:r>
                <a: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onacosane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altLang="zh-CN" sz="12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mponent 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)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矩形 11"/>
            <p:cNvSpPr/>
            <p:nvPr/>
          </p:nvSpPr>
          <p:spPr>
            <a:xfrm>
              <a:off x="354087" y="2158755"/>
              <a:ext cx="299524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WAS</a:t>
              </a:r>
              <a:r>
                <a:rPr lang="zh-CN" alt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on</a:t>
              </a:r>
              <a:r>
                <a: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exacosanol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zh-CN" sz="12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mponent 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1)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矩形 15"/>
            <p:cNvSpPr/>
            <p:nvPr/>
          </p:nvSpPr>
          <p:spPr>
            <a:xfrm>
              <a:off x="3522439" y="2162561"/>
              <a:ext cx="3407408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WAS</a:t>
              </a:r>
              <a:r>
                <a:rPr lang="zh-CN" alt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on</a:t>
              </a:r>
              <a:r>
                <a: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exacosanoic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 acid 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zh-CN" sz="12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mponent 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)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矩形 17"/>
            <p:cNvSpPr/>
            <p:nvPr/>
          </p:nvSpPr>
          <p:spPr>
            <a:xfrm>
              <a:off x="354087" y="3813302"/>
              <a:ext cx="3160545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WAS</a:t>
              </a:r>
              <a:r>
                <a:rPr lang="zh-CN" alt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on</a:t>
              </a:r>
              <a:r>
                <a: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entriacontane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zh-CN" sz="12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mponent 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)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矩形 19"/>
            <p:cNvSpPr/>
            <p:nvPr/>
          </p:nvSpPr>
          <p:spPr>
            <a:xfrm>
              <a:off x="3522439" y="3818743"/>
              <a:ext cx="2974597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WAS</a:t>
              </a:r>
              <a:r>
                <a:rPr lang="zh-CN" alt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on</a:t>
              </a:r>
              <a:r>
                <a: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ctacosanol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zh-CN" sz="12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mponent 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)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 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矩形 24"/>
            <p:cNvSpPr/>
            <p:nvPr/>
          </p:nvSpPr>
          <p:spPr>
            <a:xfrm>
              <a:off x="383343" y="5259116"/>
              <a:ext cx="2956515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WAS</a:t>
              </a:r>
              <a:r>
                <a:rPr lang="zh-CN" alt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on</a:t>
              </a:r>
              <a:r>
                <a: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Triacontanol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zh-CN" sz="12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mponent 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)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矩形 27"/>
            <p:cNvSpPr/>
            <p:nvPr/>
          </p:nvSpPr>
          <p:spPr>
            <a:xfrm>
              <a:off x="3522439" y="5229286"/>
              <a:ext cx="3083601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WAS</a:t>
              </a:r>
              <a:r>
                <a:rPr lang="zh-CN" alt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on</a:t>
              </a:r>
              <a:r>
                <a: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Oleanolic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 acid 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zh-CN" sz="12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mponent 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6)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矩形 30"/>
            <p:cNvSpPr/>
            <p:nvPr/>
          </p:nvSpPr>
          <p:spPr>
            <a:xfrm>
              <a:off x="385473" y="6843079"/>
              <a:ext cx="2913683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WAS</a:t>
              </a:r>
              <a:r>
                <a:rPr lang="zh-CN" alt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on</a:t>
              </a:r>
              <a:r>
                <a: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Ursolic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 acid 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zh-CN" sz="12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mponent 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7)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4" name="TextBox 33"/>
          <p:cNvSpPr txBox="1"/>
          <p:nvPr/>
        </p:nvSpPr>
        <p:spPr>
          <a:xfrm>
            <a:off x="332656" y="7417698"/>
            <a:ext cx="6358099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2 The GWAS 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sults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of different wax components of apple leaves (</a:t>
            </a:r>
            <a:r>
              <a:rPr lang="en-US" altLang="zh-CN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mponents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9 to 17).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he GWAS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sults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of different wax components of apple leaves.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anhattan plots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of GWAS is on the left. The chromosome number is plotted on the X-axis, and the -log</a:t>
            </a:r>
            <a:r>
              <a:rPr lang="en-US" altLang="zh-CN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value of the 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p-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value is plotted on Y-axis. The dotted lines indicate -log</a:t>
            </a:r>
            <a:r>
              <a:rPr lang="en-US" altLang="zh-CN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=5. </a:t>
            </a:r>
            <a:r>
              <a:rPr lang="en-US" altLang="zh-CN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Quantile-quantile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Q-Q)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lots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WAS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s on the right. The expected -log</a:t>
            </a:r>
            <a:r>
              <a:rPr lang="en-US" altLang="zh-CN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value of the 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value is on the X-axis and the observed -log</a:t>
            </a:r>
            <a:r>
              <a:rPr lang="en-US" altLang="zh-CN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value of the p-value is on Y-axis.</a:t>
            </a:r>
            <a:endParaRPr lang="zh-CN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849" y="715081"/>
            <a:ext cx="2880000" cy="7200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28409" y="715081"/>
            <a:ext cx="2880000" cy="720000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477" y="2310632"/>
            <a:ext cx="2880000" cy="72000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17032" y="2310632"/>
            <a:ext cx="2880000" cy="720000"/>
          </a:xfrm>
          <a:prstGeom prst="rect">
            <a:avLst/>
          </a:prstGeom>
        </p:spPr>
      </p:pic>
      <p:pic>
        <p:nvPicPr>
          <p:cNvPr id="36" name="图片 3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638" y="3920627"/>
            <a:ext cx="2880000" cy="720000"/>
          </a:xfrm>
          <a:prstGeom prst="rect">
            <a:avLst/>
          </a:prstGeom>
        </p:spPr>
      </p:pic>
      <p:pic>
        <p:nvPicPr>
          <p:cNvPr id="37" name="图片 36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17032" y="3920624"/>
            <a:ext cx="2880000" cy="720000"/>
          </a:xfrm>
          <a:prstGeom prst="rect">
            <a:avLst/>
          </a:prstGeom>
        </p:spPr>
      </p:pic>
      <p:pic>
        <p:nvPicPr>
          <p:cNvPr id="38" name="图片 37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638" y="5383649"/>
            <a:ext cx="2880000" cy="720000"/>
          </a:xfrm>
          <a:prstGeom prst="rect">
            <a:avLst/>
          </a:prstGeom>
        </p:spPr>
      </p:pic>
      <p:pic>
        <p:nvPicPr>
          <p:cNvPr id="39" name="图片 38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43973" y="5383649"/>
            <a:ext cx="2880000" cy="720000"/>
          </a:xfrm>
          <a:prstGeom prst="rect">
            <a:avLst/>
          </a:prstGeom>
        </p:spPr>
      </p:pic>
      <p:pic>
        <p:nvPicPr>
          <p:cNvPr id="40" name="图片 39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638" y="6832009"/>
            <a:ext cx="2880000" cy="72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160656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组合 6"/>
          <p:cNvGrpSpPr/>
          <p:nvPr/>
        </p:nvGrpSpPr>
        <p:grpSpPr>
          <a:xfrm>
            <a:off x="0" y="467546"/>
            <a:ext cx="6776274" cy="6615311"/>
            <a:chOff x="70987" y="2440163"/>
            <a:chExt cx="6776274" cy="6615311"/>
          </a:xfrm>
        </p:grpSpPr>
        <p:pic>
          <p:nvPicPr>
            <p:cNvPr id="4" name="Picture 3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0987" y="2440163"/>
              <a:ext cx="3868226" cy="34157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" name="Picture 4" descr="C:\Users\曹富国\Desktop\文章\GO\GWAS.trait10.separate.GOenrich-2.jpg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06176" y="2440163"/>
              <a:ext cx="2870098" cy="346000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" name="Picture 2" descr="C:\Users\曹富国\Desktop\文章\GO\GWAS.trait10.separate.GOenrich-3.jpg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17032" y="5855897"/>
              <a:ext cx="3130229" cy="319957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8" name="矩形 7"/>
          <p:cNvSpPr/>
          <p:nvPr/>
        </p:nvSpPr>
        <p:spPr>
          <a:xfrm>
            <a:off x="188640" y="7308305"/>
            <a:ext cx="628116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Gene Ontology (GO) annotation of all associated genes above the threshold line from GWAS result of </a:t>
            </a:r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nonacosane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zh-CN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342236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组合 6"/>
          <p:cNvGrpSpPr/>
          <p:nvPr/>
        </p:nvGrpSpPr>
        <p:grpSpPr>
          <a:xfrm>
            <a:off x="836712" y="1043608"/>
            <a:ext cx="4821586" cy="5383109"/>
            <a:chOff x="516043" y="2070822"/>
            <a:chExt cx="6367524" cy="6876175"/>
          </a:xfrm>
        </p:grpSpPr>
        <p:pic>
          <p:nvPicPr>
            <p:cNvPr id="4" name="Picture 2" descr="C:\Users\曹富国\Desktop\文章\GO\GWAS.trait13.separate.GOenrich-1.jpg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6043" y="2070822"/>
              <a:ext cx="3059662" cy="339030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" name="Picture 3" descr="C:\Users\曹富国\Desktop\文章\GO\GWAS.trait13.separate.GOenrich-2.jpg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91692" y="2070822"/>
              <a:ext cx="3091875" cy="339030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" name="Picture 4" descr="C:\Users\曹富国\Desktop\文章\GO\GWAS.trait13.separate.GOenrich-3.jpg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76404" y="5483717"/>
              <a:ext cx="5482228" cy="346328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8" name="矩形 7"/>
          <p:cNvSpPr/>
          <p:nvPr/>
        </p:nvSpPr>
        <p:spPr>
          <a:xfrm>
            <a:off x="332656" y="7146798"/>
            <a:ext cx="601842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Gene Ontology (GO) annotation of all associated genes above the threshold line from GWAS result of </a:t>
            </a:r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hentriacontane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zh-CN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2181450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组合 7"/>
          <p:cNvGrpSpPr/>
          <p:nvPr/>
        </p:nvGrpSpPr>
        <p:grpSpPr>
          <a:xfrm>
            <a:off x="156027" y="1331641"/>
            <a:ext cx="6570533" cy="5531364"/>
            <a:chOff x="404664" y="2380402"/>
            <a:chExt cx="6570533" cy="5531363"/>
          </a:xfrm>
        </p:grpSpPr>
        <p:pic>
          <p:nvPicPr>
            <p:cNvPr id="4" name="Picture 2" descr="C:\Users\曹富国\Desktop\文章\GO\GWAS.trait16.separate.GOenrich-1.jpg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4664" y="2380402"/>
              <a:ext cx="3409147" cy="280831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" name="Picture 3" descr="C:\Users\曹富国\Desktop\文章\GO\GWAS.trait16.separate.GOenrich-2.jpg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61047" y="2380402"/>
              <a:ext cx="2964935" cy="280831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" name="Picture 4" descr="C:\Users\曹富国\Desktop\文章\GO\GWAS.trait16.separate.GOenrich-3.jpg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17597" y="5168565"/>
              <a:ext cx="3657600" cy="27432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7" name="矩形 6"/>
          <p:cNvSpPr/>
          <p:nvPr/>
        </p:nvSpPr>
        <p:spPr>
          <a:xfrm>
            <a:off x="188640" y="7812362"/>
            <a:ext cx="624988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Gene Ontology (GO) annotation of all associated genes above the threshold line from GWAS result of </a:t>
            </a:r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oleanolic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acid. </a:t>
            </a:r>
            <a:endParaRPr lang="zh-CN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8697913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矩形 6"/>
          <p:cNvSpPr/>
          <p:nvPr/>
        </p:nvSpPr>
        <p:spPr>
          <a:xfrm>
            <a:off x="260648" y="7214231"/>
            <a:ext cx="626469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GO (Gene Ontology) annotation of all associated genes above the threshold line from GWAS 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sults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of all co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ponents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zh-CN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98" name="Picture 2" descr="C:\Users\曹富国\Desktop\文章\GO\GWAS.ALL.separate.GOenrich-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6632" y="849366"/>
            <a:ext cx="3683970" cy="27629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99" name="Picture 3" descr="C:\Users\曹富国\Desktop\文章\GO\GWAS.ALL.separate.GOenrich-2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33056" y="853582"/>
            <a:ext cx="2799083" cy="27587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0" name="Picture 4" descr="C:\Users\曹富国\Desktop\文章\GO\GWAS.ALL.separate.GOenrich-3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7593" y="3935728"/>
            <a:ext cx="3683970" cy="29325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20315216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组合 6"/>
          <p:cNvGrpSpPr/>
          <p:nvPr/>
        </p:nvGrpSpPr>
        <p:grpSpPr>
          <a:xfrm>
            <a:off x="1700808" y="710616"/>
            <a:ext cx="3312283" cy="4124274"/>
            <a:chOff x="450198" y="2319934"/>
            <a:chExt cx="3312283" cy="4124274"/>
          </a:xfrm>
        </p:grpSpPr>
        <p:sp>
          <p:nvSpPr>
            <p:cNvPr id="5" name="TextBox 4"/>
            <p:cNvSpPr txBox="1"/>
            <p:nvPr/>
          </p:nvSpPr>
          <p:spPr>
            <a:xfrm>
              <a:off x="1189448" y="2403421"/>
              <a:ext cx="85461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zh-CN" altLang="en-US" dirty="0"/>
            </a:p>
          </p:txBody>
        </p:sp>
        <p:sp>
          <p:nvSpPr>
            <p:cNvPr id="16" name="矩形 15"/>
            <p:cNvSpPr/>
            <p:nvPr/>
          </p:nvSpPr>
          <p:spPr>
            <a:xfrm rot="16200000">
              <a:off x="-1110384" y="3880516"/>
              <a:ext cx="3398163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>
                <a:defRPr lang="zh-CN" altLang="zh-CN" sz="1200" b="0" i="0" u="none" strike="noStrike" kern="1200" baseline="0" dirty="0">
                  <a:solidFill>
                    <a:prstClr val="black"/>
                  </a:solidFill>
                  <a:effectLst/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defRPr>
              </a:pP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Content</a:t>
              </a:r>
              <a:r>
                <a:rPr lang="zh-CN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of</a:t>
              </a:r>
              <a:r>
                <a:rPr lang="zh-CN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 err="1">
                  <a:solidFill>
                    <a:prstClr val="black"/>
                  </a:solidFill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nonacosane</a:t>
              </a:r>
              <a:r>
                <a:rPr lang="zh-CN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μg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/cm</a:t>
              </a:r>
              <a:r>
                <a:rPr lang="en-US" altLang="zh-CN" sz="12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zh-CN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" name="图片 2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57" b="10470"/>
            <a:stretch/>
          </p:blipFill>
          <p:spPr>
            <a:xfrm>
              <a:off x="727197" y="2403421"/>
              <a:ext cx="3035284" cy="3197256"/>
            </a:xfrm>
            <a:prstGeom prst="rect">
              <a:avLst/>
            </a:prstGeom>
          </p:spPr>
        </p:pic>
        <p:graphicFrame>
          <p:nvGraphicFramePr>
            <p:cNvPr id="8" name="内容占位符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17166954"/>
                </p:ext>
              </p:extLst>
            </p:nvPr>
          </p:nvGraphicFramePr>
          <p:xfrm>
            <a:off x="795398" y="5604871"/>
            <a:ext cx="2921633" cy="839337"/>
          </p:xfrm>
          <a:graphic>
            <a:graphicData uri="http://schemas.openxmlformats.org/drawingml/2006/table">
              <a:tbl>
                <a:tblPr/>
                <a:tblGrid>
                  <a:gridCol w="749137"/>
                  <a:gridCol w="749137"/>
                  <a:gridCol w="1423359"/>
                </a:tblGrid>
                <a:tr h="410503">
                  <a:tc>
                    <a:txBody>
                      <a:bodyPr/>
                      <a:lstStyle/>
                      <a:p>
                        <a:pPr algn="ctr" fontAlgn="ctr"/>
                        <a:r>
                          <a:rPr lang="en-US" sz="1200" b="0" i="0" u="none" strike="noStrike" dirty="0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Haplotype</a:t>
                        </a:r>
                      </a:p>
                    </a:txBody>
                    <a:tcPr marL="9525" marR="9525" marT="9525" marB="0" anchor="ctr">
                      <a:lnL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 fontAlgn="ctr"/>
                        <a:r>
                          <a:rPr lang="en-US" sz="1200" b="0" i="0" u="none" strike="noStrike" dirty="0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Chr02</a:t>
                        </a:r>
                        <a:r>
                          <a:rPr lang="en-US" sz="1200" b="0" i="0" u="none" strike="noStrike" dirty="0" smtClean="0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:</a:t>
                        </a:r>
                      </a:p>
                      <a:p>
                        <a:pPr algn="ctr" fontAlgn="ctr"/>
                        <a:r>
                          <a:rPr lang="en-US" sz="1200" b="0" i="0" u="none" strike="noStrike" dirty="0" smtClean="0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6848742</a:t>
                        </a:r>
                        <a:endPara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a:txBody>
                    <a:tcPr marL="9525" marR="9525" marT="9525" marB="0" anchor="ctr">
                      <a:lnL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 fontAlgn="ctr"/>
                        <a:r>
                          <a:rPr lang="en-US" sz="1200" b="0" i="0" u="none" strike="noStrike" dirty="0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Number of accessions</a:t>
                        </a:r>
                      </a:p>
                    </a:txBody>
                    <a:tcPr marL="9525" marR="9525" marT="9525" marB="0" anchor="ctr">
                      <a:lnL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</a:tr>
                <a:tr h="210461">
                  <a:tc>
                    <a:txBody>
                      <a:bodyPr/>
                      <a:lstStyle/>
                      <a:p>
                        <a:pPr algn="ctr" fontAlgn="ctr"/>
                        <a:r>
                          <a:rPr lang="en-US" sz="1200" b="0" i="0" u="none" strike="noStrike" dirty="0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Hap1</a:t>
                        </a:r>
                      </a:p>
                    </a:txBody>
                    <a:tcPr marL="9525" marR="9525" marT="9525" marB="0" anchor="ctr">
                      <a:lnL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 fontAlgn="ctr"/>
                        <a:r>
                          <a:rPr lang="en-US" sz="1200" b="0" i="0" u="none" strike="noStrike" dirty="0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C</a:t>
                        </a:r>
                      </a:p>
                    </a:txBody>
                    <a:tcPr marL="9525" marR="9525" marT="9525" marB="0" anchor="ctr">
                      <a:lnL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 fontAlgn="ctr"/>
                        <a:r>
                          <a:rPr lang="en-US" altLang="zh-CN" sz="1200" b="0" i="0" u="none" strike="noStrike" dirty="0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76</a:t>
                        </a:r>
                      </a:p>
                    </a:txBody>
                    <a:tcPr marL="9525" marR="9525" marT="9525" marB="0" anchor="ctr">
                      <a:lnL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</a:tr>
                <a:tr h="218373">
                  <a:tc>
                    <a:txBody>
                      <a:bodyPr/>
                      <a:lstStyle/>
                      <a:p>
                        <a:pPr algn="ctr" fontAlgn="ctr"/>
                        <a:r>
                          <a: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Hap2</a:t>
                        </a:r>
                      </a:p>
                    </a:txBody>
                    <a:tcPr marL="9525" marR="9525" marT="9525" marB="0" anchor="ctr">
                      <a:lnL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 fontAlgn="ctr"/>
                        <a:r>
                          <a:rPr lang="en-US" sz="1200" b="0" i="0" u="none" strike="noStrike" dirty="0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T</a:t>
                        </a:r>
                      </a:p>
                    </a:txBody>
                    <a:tcPr marL="9525" marR="9525" marT="9525" marB="0" anchor="ctr">
                      <a:lnL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 fontAlgn="ctr"/>
                        <a:r>
                          <a:rPr lang="en-US" altLang="zh-CN" sz="1200" b="0" i="0" u="none" strike="noStrike" dirty="0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39</a:t>
                        </a:r>
                      </a:p>
                    </a:txBody>
                    <a:tcPr marL="9525" marR="9525" marT="9525" marB="0" anchor="ctr">
                      <a:lnL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</a:tr>
              </a:tbl>
            </a:graphicData>
          </a:graphic>
        </p:graphicFrame>
      </p:grpSp>
      <p:sp>
        <p:nvSpPr>
          <p:cNvPr id="14" name="矩形 13"/>
          <p:cNvSpPr/>
          <p:nvPr/>
        </p:nvSpPr>
        <p:spPr>
          <a:xfrm>
            <a:off x="149361" y="5076056"/>
            <a:ext cx="6669361" cy="221599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defRPr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omparative analyses of </a:t>
            </a:r>
            <a:r>
              <a:rPr lang="en-US" altLang="zh-CN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MdACBP6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between the low and high </a:t>
            </a:r>
            <a:r>
              <a:rPr lang="en-US" altLang="zh-CN" sz="1200" b="1" dirty="0" err="1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nonacosane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aplotypes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ccording to the most significant SNP 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f the </a:t>
            </a:r>
            <a:r>
              <a:rPr lang="en-US" altLang="zh-CN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MdACBP6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promoter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oxplot shows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he content</a:t>
            </a:r>
            <a:r>
              <a:rPr lang="zh-CN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zh-CN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 err="1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nonacosane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each haplotype. The box expresses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he upper,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e median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nd lower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quartiles, and the dots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present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extremes.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ifferent letters indicate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ignificant differences at </a:t>
            </a:r>
            <a:r>
              <a:rPr lang="en-US" altLang="zh-CN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&lt;0.05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ccording to one-way analysis of variance (ANOVA).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able represents the location of the most significant SNP of 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MdACBP6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promoter and the accessions number corresponding to each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aplotype.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454046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组合 5"/>
          <p:cNvGrpSpPr/>
          <p:nvPr/>
        </p:nvGrpSpPr>
        <p:grpSpPr>
          <a:xfrm>
            <a:off x="1772816" y="899592"/>
            <a:ext cx="3373343" cy="4127101"/>
            <a:chOff x="724069" y="2538901"/>
            <a:chExt cx="3373343" cy="4127101"/>
          </a:xfrm>
        </p:grpSpPr>
        <p:sp>
          <p:nvSpPr>
            <p:cNvPr id="15" name="矩形 14"/>
            <p:cNvSpPr/>
            <p:nvPr/>
          </p:nvSpPr>
          <p:spPr>
            <a:xfrm rot="16200000">
              <a:off x="-884150" y="4147120"/>
              <a:ext cx="349343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>
                <a:defRPr lang="zh-CN" altLang="zh-CN" sz="1200" b="0" i="0" u="none" strike="noStrike" kern="1200" baseline="0" dirty="0">
                  <a:solidFill>
                    <a:prstClr val="black"/>
                  </a:solidFill>
                  <a:effectLst/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defRPr>
              </a:pP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Content</a:t>
              </a:r>
              <a:r>
                <a:rPr lang="zh-CN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of</a:t>
              </a:r>
              <a:r>
                <a:rPr lang="zh-CN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oleanolic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  acid </a:t>
              </a:r>
              <a:r>
                <a:rPr lang="zh-CN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μg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/cm</a:t>
              </a:r>
              <a:r>
                <a:rPr lang="en-US" altLang="zh-CN" sz="12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zh-CN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" name="图片 2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20" b="12060"/>
            <a:stretch/>
          </p:blipFill>
          <p:spPr>
            <a:xfrm>
              <a:off x="1001068" y="2559983"/>
              <a:ext cx="3096344" cy="3239977"/>
            </a:xfrm>
            <a:prstGeom prst="rect">
              <a:avLst/>
            </a:prstGeom>
          </p:spPr>
        </p:pic>
        <p:graphicFrame>
          <p:nvGraphicFramePr>
            <p:cNvPr id="9" name="内容占位符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055612516"/>
                </p:ext>
              </p:extLst>
            </p:nvPr>
          </p:nvGraphicFramePr>
          <p:xfrm>
            <a:off x="1088740" y="5833898"/>
            <a:ext cx="2988332" cy="832104"/>
          </p:xfrm>
          <a:graphic>
            <a:graphicData uri="http://schemas.openxmlformats.org/drawingml/2006/table">
              <a:tbl>
                <a:tblPr/>
                <a:tblGrid>
                  <a:gridCol w="720080"/>
                  <a:gridCol w="792088"/>
                  <a:gridCol w="1476164"/>
                </a:tblGrid>
                <a:tr h="410838">
                  <a:tc>
                    <a:txBody>
                      <a:bodyPr/>
                      <a:lstStyle/>
                      <a:p>
                        <a:pPr algn="ctr" fontAlgn="ctr"/>
                        <a:r>
                          <a:rPr lang="en-US" sz="1200" b="0" i="0" u="none" strike="noStrike" dirty="0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Haplotype</a:t>
                        </a:r>
                      </a:p>
                    </a:txBody>
                    <a:tcPr marL="9525" marR="9525" marT="9525" marB="0" anchor="ctr">
                      <a:lnL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 fontAlgn="ctr"/>
                        <a:r>
                          <a:rPr lang="en-US" sz="1200" b="0" i="0" u="none" strike="noStrike" dirty="0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Chr16</a:t>
                        </a:r>
                        <a:r>
                          <a:rPr lang="en-US" sz="1200" b="0" i="0" u="none" strike="noStrike" dirty="0" smtClean="0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:</a:t>
                        </a:r>
                      </a:p>
                      <a:p>
                        <a:pPr algn="ctr" fontAlgn="ctr"/>
                        <a:r>
                          <a:rPr lang="en-US" sz="1200" b="0" i="0" u="none" strike="noStrike" dirty="0" smtClean="0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3605344</a:t>
                        </a:r>
                        <a:endPara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a:txBody>
                    <a:tcPr marL="9525" marR="9525" marT="9525" marB="0" anchor="ctr">
                      <a:lnL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 fontAlgn="ctr"/>
                        <a:r>
                          <a:rPr lang="en-US" sz="1200" b="0" i="0" u="none" strike="noStrike" dirty="0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Number of </a:t>
                        </a:r>
                        <a:endPara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  <a:p>
                        <a:pPr algn="ctr" fontAlgn="ctr"/>
                        <a:r>
                          <a:rPr lang="en-US" sz="1200" b="0" i="0" u="none" strike="noStrike" dirty="0" smtClean="0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accessions</a:t>
                        </a:r>
                        <a:endPara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a:txBody>
                    <a:tcPr marL="9525" marR="9525" marT="9525" marB="0" anchor="ctr">
                      <a:lnL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</a:tr>
                <a:tr h="210633">
                  <a:tc>
                    <a:txBody>
                      <a:bodyPr/>
                      <a:lstStyle/>
                      <a:p>
                        <a:pPr algn="ctr" fontAlgn="ctr"/>
                        <a:r>
                          <a: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Hap1</a:t>
                        </a:r>
                      </a:p>
                    </a:txBody>
                    <a:tcPr marL="9525" marR="9525" marT="9525" marB="0" anchor="ctr">
                      <a:lnL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 fontAlgn="ctr"/>
                        <a:r>
                          <a:rPr lang="en-US" sz="1200" b="0" i="0" u="none" strike="noStrike" dirty="0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C</a:t>
                        </a:r>
                      </a:p>
                    </a:txBody>
                    <a:tcPr marL="9525" marR="9525" marT="9525" marB="0" anchor="ctr">
                      <a:lnL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 fontAlgn="ctr"/>
                        <a:r>
                          <a:rPr lang="en-US" altLang="zh-CN" sz="1200" b="0" i="0" u="none" strike="noStrike" dirty="0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93</a:t>
                        </a:r>
                      </a:p>
                    </a:txBody>
                    <a:tcPr marL="9525" marR="9525" marT="9525" marB="0" anchor="ctr">
                      <a:lnL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</a:tr>
                <a:tr h="210633">
                  <a:tc>
                    <a:txBody>
                      <a:bodyPr/>
                      <a:lstStyle/>
                      <a:p>
                        <a:pPr algn="ctr" fontAlgn="ctr"/>
                        <a:r>
                          <a:rPr lang="en-US" sz="1200" b="0" i="0" u="none" strike="noStrike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Hap2</a:t>
                        </a:r>
                      </a:p>
                    </a:txBody>
                    <a:tcPr marL="9525" marR="9525" marT="9525" marB="0" anchor="ctr">
                      <a:lnL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 fontAlgn="ctr"/>
                        <a:r>
                          <a:rPr lang="en-US" sz="1200" b="0" i="0" u="none" strike="noStrike" dirty="0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G</a:t>
                        </a:r>
                      </a:p>
                    </a:txBody>
                    <a:tcPr marL="9525" marR="9525" marT="9525" marB="0" anchor="ctr">
                      <a:lnL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  <a:tc>
                    <a:txBody>
                      <a:bodyPr/>
                      <a:lstStyle/>
                      <a:p>
                        <a:pPr algn="ctr" fontAlgn="ctr"/>
                        <a:r>
                          <a:rPr lang="en-US" altLang="zh-CN" sz="1200" b="0" i="0" u="none" strike="noStrike" dirty="0">
                            <a:solidFill>
                              <a:srgbClr val="000000"/>
                            </a:solidFill>
                            <a:effectLst/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9</a:t>
                        </a:r>
                      </a:p>
                    </a:txBody>
                    <a:tcPr marL="9525" marR="9525" marT="9525" marB="0" anchor="ctr">
                      <a:lnL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L>
                      <a:lnR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R>
                      <a:lnT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T>
                      <a:lnB w="12700" cap="flat" cmpd="sng" algn="ctr">
                        <a:solidFill>
                          <a:schemeClr val="tx1"/>
                        </a:solidFill>
                        <a:prstDash val="solid"/>
                        <a:round/>
                        <a:headEnd type="none" w="med" len="med"/>
                        <a:tailEnd type="none" w="med" len="med"/>
                      </a:lnB>
                    </a:tcPr>
                  </a:tc>
                </a:tr>
              </a:tbl>
            </a:graphicData>
          </a:graphic>
        </p:graphicFrame>
      </p:grpSp>
      <p:sp>
        <p:nvSpPr>
          <p:cNvPr id="13" name="矩形 12"/>
          <p:cNvSpPr/>
          <p:nvPr/>
        </p:nvSpPr>
        <p:spPr>
          <a:xfrm>
            <a:off x="113409" y="5436096"/>
            <a:ext cx="6669361" cy="221599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defRPr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8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omparative analyses of </a:t>
            </a:r>
            <a:r>
              <a:rPr lang="en-US" altLang="zh-CN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MdABCG21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between the low and high </a:t>
            </a:r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oleanolic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cid haplotypes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ccording to the most significant SNP 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f the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MdABCG21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promoter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oxplot shows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he content</a:t>
            </a:r>
            <a:r>
              <a:rPr lang="zh-CN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zh-CN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oleanolic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acid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of each haplotype. The box expresses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he upper,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e median, and lower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quartiles, and the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ots represent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extremes. Different letters indicate significant differences at </a:t>
            </a:r>
            <a:r>
              <a:rPr lang="en-US" altLang="zh-CN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&lt;0.05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ccording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o one-way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nalysis of variance (ANOVA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. The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able represents the location of the most significant SNP of 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MdABCG21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romoter and the accessions number corresponding to each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aplotype.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8128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表格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93540901"/>
              </p:ext>
            </p:extLst>
          </p:nvPr>
        </p:nvGraphicFramePr>
        <p:xfrm>
          <a:off x="237286" y="3135293"/>
          <a:ext cx="2743200" cy="760095"/>
        </p:xfrm>
        <a:graphic>
          <a:graphicData uri="http://schemas.openxmlformats.org/drawingml/2006/table">
            <a:tbl>
              <a:tblPr/>
              <a:tblGrid>
                <a:gridCol w="685800"/>
                <a:gridCol w="1137762"/>
                <a:gridCol w="919638"/>
              </a:tblGrid>
              <a:tr h="1714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plotyp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09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:</a:t>
                      </a:r>
                    </a:p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26316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 of accession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p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14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p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pSp>
        <p:nvGrpSpPr>
          <p:cNvPr id="8" name="组合 7"/>
          <p:cNvGrpSpPr/>
          <p:nvPr/>
        </p:nvGrpSpPr>
        <p:grpSpPr>
          <a:xfrm>
            <a:off x="277113" y="323528"/>
            <a:ext cx="2703373" cy="3004959"/>
            <a:chOff x="529868" y="622593"/>
            <a:chExt cx="2703373" cy="3004959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03" b="11302"/>
            <a:stretch/>
          </p:blipFill>
          <p:spPr>
            <a:xfrm>
              <a:off x="836712" y="899592"/>
              <a:ext cx="2396529" cy="2534766"/>
            </a:xfrm>
            <a:prstGeom prst="rect">
              <a:avLst/>
            </a:prstGeom>
          </p:spPr>
        </p:pic>
        <p:sp>
          <p:nvSpPr>
            <p:cNvPr id="5" name="矩形 4"/>
            <p:cNvSpPr/>
            <p:nvPr/>
          </p:nvSpPr>
          <p:spPr>
            <a:xfrm rot="16200000">
              <a:off x="-792210" y="2028475"/>
              <a:ext cx="2921155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>
                <a:defRPr lang="zh-CN" altLang="zh-CN" sz="1200" b="0" i="0" u="none" strike="noStrike" kern="1200" baseline="0" dirty="0">
                  <a:solidFill>
                    <a:prstClr val="black"/>
                  </a:solidFill>
                  <a:effectLst/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defRPr>
              </a:pP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Content</a:t>
              </a:r>
              <a:r>
                <a:rPr lang="zh-CN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of</a:t>
              </a:r>
              <a:r>
                <a:rPr lang="zh-CN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 err="1">
                  <a:solidFill>
                    <a:prstClr val="black"/>
                  </a:solidFill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nonacosane</a:t>
              </a:r>
              <a:r>
                <a:rPr lang="zh-CN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μg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/cm</a:t>
              </a:r>
              <a:r>
                <a:rPr lang="en-US" altLang="zh-CN" sz="12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zh-CN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1628800" y="622593"/>
              <a:ext cx="15121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dLTP4</a:t>
              </a:r>
              <a:endParaRPr lang="zh-CN" altLang="en-US" sz="12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9" name="组合 18"/>
          <p:cNvGrpSpPr/>
          <p:nvPr/>
        </p:nvGrpSpPr>
        <p:grpSpPr>
          <a:xfrm>
            <a:off x="3764905" y="314796"/>
            <a:ext cx="2721905" cy="2947488"/>
            <a:chOff x="3764905" y="314796"/>
            <a:chExt cx="2721905" cy="2947488"/>
          </a:xfrm>
        </p:grpSpPr>
        <p:pic>
          <p:nvPicPr>
            <p:cNvPr id="9" name="图片 8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49" b="11840"/>
            <a:stretch/>
          </p:blipFill>
          <p:spPr>
            <a:xfrm>
              <a:off x="4077072" y="591796"/>
              <a:ext cx="2409738" cy="2534766"/>
            </a:xfrm>
            <a:prstGeom prst="rect">
              <a:avLst/>
            </a:prstGeom>
          </p:spPr>
        </p:pic>
        <p:sp>
          <p:nvSpPr>
            <p:cNvPr id="10" name="矩形 9"/>
            <p:cNvSpPr/>
            <p:nvPr/>
          </p:nvSpPr>
          <p:spPr>
            <a:xfrm rot="16200000">
              <a:off x="2442827" y="1663207"/>
              <a:ext cx="2921155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>
                <a:defRPr lang="zh-CN" altLang="zh-CN" sz="1200" b="0" i="0" u="none" strike="noStrike" kern="1200" baseline="0" dirty="0">
                  <a:solidFill>
                    <a:prstClr val="black"/>
                  </a:solidFill>
                  <a:effectLst/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defRPr>
              </a:pP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Content</a:t>
              </a:r>
              <a:r>
                <a:rPr lang="zh-CN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of</a:t>
              </a:r>
              <a:r>
                <a:rPr lang="zh-CN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 err="1">
                  <a:solidFill>
                    <a:prstClr val="black"/>
                  </a:solidFill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nonacosane</a:t>
              </a:r>
              <a:r>
                <a:rPr lang="zh-CN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μg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/cm</a:t>
              </a:r>
              <a:r>
                <a:rPr lang="en-US" altLang="zh-CN" sz="12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zh-CN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972707" y="314796"/>
              <a:ext cx="15121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dWSD1</a:t>
              </a:r>
              <a:endParaRPr lang="zh-CN" altLang="en-US" sz="12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12" name="内容占位符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209325686"/>
              </p:ext>
            </p:extLst>
          </p:nvPr>
        </p:nvGraphicFramePr>
        <p:xfrm>
          <a:off x="3764905" y="3137655"/>
          <a:ext cx="2719970" cy="760095"/>
        </p:xfrm>
        <a:graphic>
          <a:graphicData uri="http://schemas.openxmlformats.org/drawingml/2006/table">
            <a:tbl>
              <a:tblPr/>
              <a:tblGrid>
                <a:gridCol w="713982"/>
                <a:gridCol w="1117418"/>
                <a:gridCol w="888570"/>
              </a:tblGrid>
              <a:tr h="34643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plotyp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17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:</a:t>
                      </a:r>
                    </a:p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60290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 of accession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21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p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7761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p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15" name="表格 1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42365913"/>
              </p:ext>
            </p:extLst>
          </p:nvPr>
        </p:nvGraphicFramePr>
        <p:xfrm>
          <a:off x="277112" y="6964288"/>
          <a:ext cx="2866759" cy="831477"/>
        </p:xfrm>
        <a:graphic>
          <a:graphicData uri="http://schemas.openxmlformats.org/drawingml/2006/table">
            <a:tbl>
              <a:tblPr/>
              <a:tblGrid>
                <a:gridCol w="716690"/>
                <a:gridCol w="1202627"/>
                <a:gridCol w="947442"/>
              </a:tblGrid>
              <a:tr h="43073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plotyp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16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:</a:t>
                      </a:r>
                    </a:p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9043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 of accession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36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p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36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p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pSp>
        <p:nvGrpSpPr>
          <p:cNvPr id="18" name="组合 17"/>
          <p:cNvGrpSpPr/>
          <p:nvPr/>
        </p:nvGrpSpPr>
        <p:grpSpPr>
          <a:xfrm>
            <a:off x="275145" y="4001232"/>
            <a:ext cx="2880717" cy="2963056"/>
            <a:chOff x="277113" y="4001232"/>
            <a:chExt cx="2880717" cy="2963056"/>
          </a:xfrm>
        </p:grpSpPr>
        <p:pic>
          <p:nvPicPr>
            <p:cNvPr id="13" name="图片 12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28" t="-1859" r="-2470" b="11114"/>
            <a:stretch/>
          </p:blipFill>
          <p:spPr>
            <a:xfrm>
              <a:off x="583957" y="4284216"/>
              <a:ext cx="2573873" cy="2680072"/>
            </a:xfrm>
            <a:prstGeom prst="rect">
              <a:avLst/>
            </a:prstGeom>
          </p:spPr>
        </p:pic>
        <p:sp>
          <p:nvSpPr>
            <p:cNvPr id="14" name="TextBox 13"/>
            <p:cNvSpPr txBox="1"/>
            <p:nvPr/>
          </p:nvSpPr>
          <p:spPr>
            <a:xfrm>
              <a:off x="1376045" y="4001232"/>
              <a:ext cx="15121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dRDR1</a:t>
              </a:r>
              <a:endParaRPr lang="zh-CN" altLang="en-US" sz="12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矩形 15"/>
            <p:cNvSpPr/>
            <p:nvPr/>
          </p:nvSpPr>
          <p:spPr>
            <a:xfrm rot="16200000">
              <a:off x="-362471" y="5518673"/>
              <a:ext cx="1490328" cy="21115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>
                <a:defRPr lang="zh-CN" altLang="zh-CN" sz="1200" b="0" i="0" u="none" strike="noStrike" kern="1200" baseline="0" dirty="0">
                  <a:solidFill>
                    <a:prstClr val="black"/>
                  </a:solidFill>
                  <a:effectLst/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defRPr>
              </a:pP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Content</a:t>
              </a:r>
              <a:r>
                <a:rPr lang="zh-CN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of</a:t>
              </a:r>
              <a:r>
                <a:rPr lang="zh-CN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hentriacontane</a:t>
              </a:r>
              <a:r>
                <a:rPr lang="zh-CN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μg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/cm</a:t>
              </a:r>
              <a:r>
                <a:rPr lang="en-US" altLang="zh-CN" sz="12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zh-CN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2945932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2</TotalTime>
  <Words>826</Words>
  <Application>Microsoft Office PowerPoint</Application>
  <PresentationFormat>全屏显示(4:3)</PresentationFormat>
  <Paragraphs>88</Paragraphs>
  <Slides>10</Slides>
  <Notes>2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0</vt:i4>
      </vt:variant>
    </vt:vector>
  </HeadingPairs>
  <TitlesOfParts>
    <vt:vector size="11" baseType="lpstr"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曹富国</dc:creator>
  <cp:lastModifiedBy>曹富国</cp:lastModifiedBy>
  <cp:revision>50</cp:revision>
  <dcterms:created xsi:type="dcterms:W3CDTF">2021-06-19T03:55:10Z</dcterms:created>
  <dcterms:modified xsi:type="dcterms:W3CDTF">2021-10-12T09:54:38Z</dcterms:modified>
</cp:coreProperties>
</file>